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  <p:sldId id="283" r:id="rId3"/>
    <p:sldId id="284" r:id="rId4"/>
    <p:sldId id="281" r:id="rId5"/>
    <p:sldId id="280" r:id="rId6"/>
    <p:sldId id="282" r:id="rId7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63" d="100"/>
          <a:sy n="63" d="100"/>
        </p:scale>
        <p:origin x="66" y="10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C0E6DAA-87D2-41D5-F844-493F59CFF46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3A9D4763-96E3-913F-022F-A37CA16A1C4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BCB504B-2114-802C-04A2-71056B300D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305308-63A4-4D54-AB13-FC9A6D291E3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180E41D-47D7-1FF3-2346-557EEA82DE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36B63DB-09CC-0AD1-C703-435FA21460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3EBF-389A-4B63-8877-152EA31E8E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65535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DEED2C0-2003-31D5-BD8B-D2DC990853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FD094113-757C-392B-220C-4414EDF89C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454724F-836E-8A73-C260-2B99895990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305308-63A4-4D54-AB13-FC9A6D291E3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48E1F6B-697D-A657-DA24-2B3E569DB0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C6DD5BA-3C2A-F307-C3C5-00623C250E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3EBF-389A-4B63-8877-152EA31E8E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550130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686F7763-2FFC-070D-DA24-08EF1114855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D6F2A037-60BB-B0E6-3010-0CD678DBAE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C1C9F31-0BD4-22E7-6CD6-3DB9438B7D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305308-63A4-4D54-AB13-FC9A6D291E3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6425F41-70F1-FC2C-7793-A3477F6F22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5BDB157-32CB-F813-2A51-FEF1881C04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3EBF-389A-4B63-8877-152EA31E8E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12871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68BDB49-0B77-356C-F8B3-81F7DE75F9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D41AC942-E80F-04ED-DAF7-4829D88F74F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CBF9565-C1B5-E8AA-BEEE-9011A1D8E8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305308-63A4-4D54-AB13-FC9A6D291E3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CCDC135-893B-8A10-D0E9-E52227B997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2025D6A-5961-40C8-6939-418340DE69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3EBF-389A-4B63-8877-152EA31E8E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81812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FFFF730-5C1F-55FD-E00C-CBC8D3D1F8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F0291A6C-EA6D-214A-1064-491B3180FA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2EF12EA-6681-8BF6-CF54-D4327AE60A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305308-63A4-4D54-AB13-FC9A6D291E3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BD25F37-0A80-5370-9FD2-DD399EFAED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790502C-F219-6DB5-B2E0-44442514B8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3EBF-389A-4B63-8877-152EA31E8E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166271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391D384-A5A2-0940-834C-6A4F03A281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CFEAD44C-FED3-57B3-5318-262D3A16F8E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9AB88875-D48A-5CC1-C83F-F141DED9D21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048E9140-A148-A611-624C-4A9F0F4D28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305308-63A4-4D54-AB13-FC9A6D291E3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D804897A-9773-E519-4E40-5AB4519F6C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77CA776-AC5B-45BB-32C8-CDD3C15106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3EBF-389A-4B63-8877-152EA31E8E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444722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30C9D57-8C3C-B073-C0D0-E0E98753E4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4328C15-DF56-E171-ED81-E4A448A330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5EB8B06B-3A78-0D6B-490F-D9C83A46B9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C141EBF8-8287-A89D-2A2E-C936400CCD5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C7E1D13F-FF01-E285-A1B0-D61C979E924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5FBFA957-A2AE-887F-037A-88C54BD3D5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305308-63A4-4D54-AB13-FC9A6D291E3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9A8030C5-4239-BC37-1C6D-858C1A901D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65902278-64A3-DD70-474A-CEA041FE82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3EBF-389A-4B63-8877-152EA31E8E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131282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1E59439-E8ED-A532-4BDE-DEE8CA1DE1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8677E90E-8227-2C8F-A7E4-60A630A14C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305308-63A4-4D54-AB13-FC9A6D291E3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94580E5B-C775-EC04-30A7-9F1125B333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419DF7E1-1CE6-7EAE-D0D4-DDBF083CE6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3EBF-389A-4B63-8877-152EA31E8E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951918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1EEAFC6F-BC71-2795-86FD-670BD50A45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305308-63A4-4D54-AB13-FC9A6D291E3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52846A08-6424-9835-762D-3A98617D37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E7F1D113-CB6D-0B34-365F-A50E1B3946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3EBF-389A-4B63-8877-152EA31E8E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660715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7BE9AD7-9148-B057-04D8-85B970375B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088D16F7-8F60-1849-3F89-D0C4E8B9C6C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F6314396-59ED-D2B2-950D-2A702A226D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F4026205-BECC-8021-CE6C-D7F4255FB8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305308-63A4-4D54-AB13-FC9A6D291E3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A6BB9F5D-4943-562E-6DC1-19B279AE86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22BF4547-8899-A332-E127-873E7CDDAF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3EBF-389A-4B63-8877-152EA31E8E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968381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ED7C76C-CF53-7DA8-0004-EEF1355FD4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C8250531-B181-CC17-BB94-0FEC0EFB9C5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0C09C165-3762-F0E4-F036-F89407F2A33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D3AB6DFA-6204-705D-E545-5E813814B5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305308-63A4-4D54-AB13-FC9A6D291E3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C76B0FC2-DD4B-CB95-9809-0E5B48D3F7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EE698814-E703-DF39-87F2-2F48AA72BB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3EBF-389A-4B63-8877-152EA31E8E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672661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13477899-5616-165F-C5ED-81EAA11EBE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94CBE4D4-78F5-35F5-C2F0-6B67075B85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66A5AF4-02F4-DEBF-E6D2-9F6EBA2908E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C305308-63A4-4D54-AB13-FC9A6D291E3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57B281A-B289-079D-3F43-2FEA3719244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2102421-F638-EECF-33B9-0896ED00667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28E3EBF-389A-4B63-8877-152EA31E8E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484995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8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그림 18">
            <a:extLst>
              <a:ext uri="{FF2B5EF4-FFF2-40B4-BE49-F238E27FC236}">
                <a16:creationId xmlns:a16="http://schemas.microsoft.com/office/drawing/2014/main" id="{A0A9DA06-5A74-FE78-6E80-0433ED8F2F6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1274939">
            <a:off x="4503876" y="489744"/>
            <a:ext cx="5940000" cy="5962414"/>
          </a:xfrm>
          <a:prstGeom prst="rect">
            <a:avLst/>
          </a:prstGeom>
        </p:spPr>
      </p:pic>
      <p:pic>
        <p:nvPicPr>
          <p:cNvPr id="22" name="그림 21">
            <a:extLst>
              <a:ext uri="{FF2B5EF4-FFF2-40B4-BE49-F238E27FC236}">
                <a16:creationId xmlns:a16="http://schemas.microsoft.com/office/drawing/2014/main" id="{B78F4775-9DDF-7362-3907-A58ACE39F7D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21274939">
            <a:off x="4503876" y="489744"/>
            <a:ext cx="5940000" cy="5962414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8FF91CB8-1C98-39B0-6A4F-D1B96E2F1B5F}"/>
              </a:ext>
            </a:extLst>
          </p:cNvPr>
          <p:cNvSpPr txBox="1"/>
          <p:nvPr/>
        </p:nvSpPr>
        <p:spPr>
          <a:xfrm>
            <a:off x="754472" y="6349922"/>
            <a:ext cx="1787848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A31D54A-B172-D6A7-7CA0-3440BBF1BC6D}"/>
              </a:ext>
            </a:extLst>
          </p:cNvPr>
          <p:cNvSpPr txBox="1"/>
          <p:nvPr/>
        </p:nvSpPr>
        <p:spPr>
          <a:xfrm>
            <a:off x="754472" y="164344"/>
            <a:ext cx="882000" cy="504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lIns="0" tIns="0" rIns="0" bIns="0" rtlCol="0" anchor="ctr" anchorCtr="0">
            <a:no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PB RFP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0826979-1670-49BB-B2D2-AEB83F66C529}"/>
              </a:ext>
            </a:extLst>
          </p:cNvPr>
          <p:cNvSpPr txBox="1"/>
          <p:nvPr/>
        </p:nvSpPr>
        <p:spPr>
          <a:xfrm>
            <a:off x="1672959" y="164344"/>
            <a:ext cx="876153" cy="504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lIns="0" tIns="0" rIns="0" bIns="0" rtlCol="0" anchor="ctr" anchorCtr="0">
            <a:noAutofit/>
          </a:bodyPr>
          <a:lstStyle/>
          <a:p>
            <a:pPr algn="ctr"/>
            <a:r>
              <a:rPr lang="en-US" altLang="ko-KR" sz="1400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GFP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</a:p>
          <a:p>
            <a:pPr algn="ctr"/>
            <a:r>
              <a:rPr lang="en-US" altLang="ko-KR" sz="1400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lx2</a:t>
            </a:r>
            <a:endParaRPr lang="ko-KR" altLang="en-US" sz="1400" b="1" dirty="0">
              <a:solidFill>
                <a:srgbClr val="FF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직선 연결선 33">
            <a:extLst>
              <a:ext uri="{FF2B5EF4-FFF2-40B4-BE49-F238E27FC236}">
                <a16:creationId xmlns:a16="http://schemas.microsoft.com/office/drawing/2014/main" id="{AF663CDD-76DC-B45B-38CE-7B65964DC1BC}"/>
              </a:ext>
            </a:extLst>
          </p:cNvPr>
          <p:cNvCxnSpPr/>
          <p:nvPr/>
        </p:nvCxnSpPr>
        <p:spPr>
          <a:xfrm>
            <a:off x="785092" y="6243781"/>
            <a:ext cx="27000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" name="직사각형 3">
            <a:extLst>
              <a:ext uri="{FF2B5EF4-FFF2-40B4-BE49-F238E27FC236}">
                <a16:creationId xmlns:a16="http://schemas.microsoft.com/office/drawing/2014/main" id="{50D1E6B6-9C0D-0FEC-F2BF-A560AF3AC369}"/>
              </a:ext>
            </a:extLst>
          </p:cNvPr>
          <p:cNvSpPr/>
          <p:nvPr/>
        </p:nvSpPr>
        <p:spPr>
          <a:xfrm>
            <a:off x="8331027" y="668344"/>
            <a:ext cx="900000" cy="560769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37C4C29C-B4B8-AB0C-CB2E-D618ABDAC7D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52202" y="704733"/>
            <a:ext cx="884270" cy="5608800"/>
          </a:xfrm>
          <a:prstGeom prst="rect">
            <a:avLst/>
          </a:prstGeom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A4A7D23E-A0A9-AB56-E4A7-414BD29AC10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69362" y="704733"/>
            <a:ext cx="884270" cy="5608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406227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>
            <a:extLst>
              <a:ext uri="{FF2B5EF4-FFF2-40B4-BE49-F238E27FC236}">
                <a16:creationId xmlns:a16="http://schemas.microsoft.com/office/drawing/2014/main" id="{68117A19-9235-B9E8-4057-64D7336C876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1447258">
            <a:off x="3070067" y="400277"/>
            <a:ext cx="5917669" cy="5940000"/>
          </a:xfrm>
          <a:prstGeom prst="rect">
            <a:avLst/>
          </a:prstGeom>
        </p:spPr>
      </p:pic>
      <p:pic>
        <p:nvPicPr>
          <p:cNvPr id="13" name="그림 12">
            <a:extLst>
              <a:ext uri="{FF2B5EF4-FFF2-40B4-BE49-F238E27FC236}">
                <a16:creationId xmlns:a16="http://schemas.microsoft.com/office/drawing/2014/main" id="{BC762126-9B34-7EFD-EBC2-425FBBAECF3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21447258">
            <a:off x="3070067" y="400277"/>
            <a:ext cx="5917669" cy="5940000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8FF91CB8-1C98-39B0-6A4F-D1B96E2F1B5F}"/>
              </a:ext>
            </a:extLst>
          </p:cNvPr>
          <p:cNvSpPr txBox="1"/>
          <p:nvPr/>
        </p:nvSpPr>
        <p:spPr>
          <a:xfrm>
            <a:off x="754472" y="6349922"/>
            <a:ext cx="1787848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p18 OE</a:t>
            </a:r>
          </a:p>
        </p:txBody>
      </p:sp>
      <p:cxnSp>
        <p:nvCxnSpPr>
          <p:cNvPr id="34" name="직선 연결선 33">
            <a:extLst>
              <a:ext uri="{FF2B5EF4-FFF2-40B4-BE49-F238E27FC236}">
                <a16:creationId xmlns:a16="http://schemas.microsoft.com/office/drawing/2014/main" id="{AF663CDD-76DC-B45B-38CE-7B65964DC1BC}"/>
              </a:ext>
            </a:extLst>
          </p:cNvPr>
          <p:cNvCxnSpPr/>
          <p:nvPr/>
        </p:nvCxnSpPr>
        <p:spPr>
          <a:xfrm>
            <a:off x="785092" y="6243781"/>
            <a:ext cx="27000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" name="직사각형 3">
            <a:extLst>
              <a:ext uri="{FF2B5EF4-FFF2-40B4-BE49-F238E27FC236}">
                <a16:creationId xmlns:a16="http://schemas.microsoft.com/office/drawing/2014/main" id="{50D1E6B6-9C0D-0FEC-F2BF-A560AF3AC369}"/>
              </a:ext>
            </a:extLst>
          </p:cNvPr>
          <p:cNvSpPr/>
          <p:nvPr/>
        </p:nvSpPr>
        <p:spPr>
          <a:xfrm>
            <a:off x="5144908" y="705288"/>
            <a:ext cx="900000" cy="560769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EE93E52-CD37-B38A-0291-05C7F8C5BD3A}"/>
              </a:ext>
            </a:extLst>
          </p:cNvPr>
          <p:cNvSpPr txBox="1"/>
          <p:nvPr/>
        </p:nvSpPr>
        <p:spPr>
          <a:xfrm>
            <a:off x="754472" y="164344"/>
            <a:ext cx="882000" cy="504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lIns="0" tIns="0" rIns="0" bIns="0" rtlCol="0" anchor="ctr" anchorCtr="0">
            <a:no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PB RFP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2C24E4C-CE21-AB1B-5FE7-BA8EC136B41B}"/>
              </a:ext>
            </a:extLst>
          </p:cNvPr>
          <p:cNvSpPr txBox="1"/>
          <p:nvPr/>
        </p:nvSpPr>
        <p:spPr>
          <a:xfrm>
            <a:off x="1672959" y="164344"/>
            <a:ext cx="876153" cy="504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lIns="0" tIns="0" rIns="0" bIns="0" rtlCol="0" anchor="ctr" anchorCtr="0">
            <a:noAutofit/>
          </a:bodyPr>
          <a:lstStyle/>
          <a:p>
            <a:pPr algn="ctr"/>
            <a:r>
              <a:rPr lang="en-US" altLang="ko-KR" sz="1400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GFP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</a:p>
          <a:p>
            <a:pPr algn="ctr"/>
            <a:r>
              <a:rPr lang="en-US" altLang="ko-KR" sz="1400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lx2</a:t>
            </a:r>
            <a:endParaRPr lang="ko-KR" altLang="en-US" sz="1400" b="1" dirty="0">
              <a:solidFill>
                <a:srgbClr val="FF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그림 5">
            <a:extLst>
              <a:ext uri="{FF2B5EF4-FFF2-40B4-BE49-F238E27FC236}">
                <a16:creationId xmlns:a16="http://schemas.microsoft.com/office/drawing/2014/main" id="{7D10BB07-3824-F758-ADDD-F668DB42C8A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51471" y="704178"/>
            <a:ext cx="891354" cy="5608800"/>
          </a:xfrm>
          <a:prstGeom prst="rect">
            <a:avLst/>
          </a:prstGeom>
        </p:spPr>
      </p:pic>
      <p:pic>
        <p:nvPicPr>
          <p:cNvPr id="9" name="그림 8">
            <a:extLst>
              <a:ext uri="{FF2B5EF4-FFF2-40B4-BE49-F238E27FC236}">
                <a16:creationId xmlns:a16="http://schemas.microsoft.com/office/drawing/2014/main" id="{86EFE506-A088-862A-3A8E-2BC441CE8E5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72959" y="704178"/>
            <a:ext cx="891353" cy="5608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654261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그림 14">
            <a:extLst>
              <a:ext uri="{FF2B5EF4-FFF2-40B4-BE49-F238E27FC236}">
                <a16:creationId xmlns:a16="http://schemas.microsoft.com/office/drawing/2014/main" id="{F68B9109-AA8B-D70D-9587-B236A88717D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3181">
            <a:off x="3628171" y="603547"/>
            <a:ext cx="5917669" cy="5940000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1DD033A3-9348-2E7F-798A-D69F9B74C0C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3181">
            <a:off x="3628171" y="603547"/>
            <a:ext cx="5917669" cy="5940000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8FF91CB8-1C98-39B0-6A4F-D1B96E2F1B5F}"/>
              </a:ext>
            </a:extLst>
          </p:cNvPr>
          <p:cNvSpPr txBox="1"/>
          <p:nvPr/>
        </p:nvSpPr>
        <p:spPr>
          <a:xfrm>
            <a:off x="754472" y="6349922"/>
            <a:ext cx="1787848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Double KD</a:t>
            </a:r>
          </a:p>
        </p:txBody>
      </p:sp>
      <p:cxnSp>
        <p:nvCxnSpPr>
          <p:cNvPr id="34" name="직선 연결선 33">
            <a:extLst>
              <a:ext uri="{FF2B5EF4-FFF2-40B4-BE49-F238E27FC236}">
                <a16:creationId xmlns:a16="http://schemas.microsoft.com/office/drawing/2014/main" id="{AF663CDD-76DC-B45B-38CE-7B65964DC1BC}"/>
              </a:ext>
            </a:extLst>
          </p:cNvPr>
          <p:cNvCxnSpPr/>
          <p:nvPr/>
        </p:nvCxnSpPr>
        <p:spPr>
          <a:xfrm>
            <a:off x="785092" y="6243781"/>
            <a:ext cx="27000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" name="직사각형 3">
            <a:extLst>
              <a:ext uri="{FF2B5EF4-FFF2-40B4-BE49-F238E27FC236}">
                <a16:creationId xmlns:a16="http://schemas.microsoft.com/office/drawing/2014/main" id="{50D1E6B6-9C0D-0FEC-F2BF-A560AF3AC369}"/>
              </a:ext>
            </a:extLst>
          </p:cNvPr>
          <p:cNvSpPr/>
          <p:nvPr/>
        </p:nvSpPr>
        <p:spPr>
          <a:xfrm>
            <a:off x="4973449" y="705288"/>
            <a:ext cx="900000" cy="560769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50CA93E-D946-7288-7BF8-9E0E4192B7AF}"/>
              </a:ext>
            </a:extLst>
          </p:cNvPr>
          <p:cNvSpPr txBox="1"/>
          <p:nvPr/>
        </p:nvSpPr>
        <p:spPr>
          <a:xfrm>
            <a:off x="754472" y="164344"/>
            <a:ext cx="882000" cy="504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lIns="0" tIns="0" rIns="0" bIns="0" rtlCol="0" anchor="ctr" anchorCtr="0">
            <a:no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PB RFP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5D71A8D-B0E3-2935-3A26-C0B361CE3A4E}"/>
              </a:ext>
            </a:extLst>
          </p:cNvPr>
          <p:cNvSpPr txBox="1"/>
          <p:nvPr/>
        </p:nvSpPr>
        <p:spPr>
          <a:xfrm>
            <a:off x="1672959" y="164344"/>
            <a:ext cx="876153" cy="504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lIns="0" tIns="0" rIns="0" bIns="0" rtlCol="0" anchor="ctr" anchorCtr="0">
            <a:noAutofit/>
          </a:bodyPr>
          <a:lstStyle/>
          <a:p>
            <a:pPr algn="ctr"/>
            <a:r>
              <a:rPr lang="en-US" altLang="ko-KR" sz="1400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GFP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</a:p>
          <a:p>
            <a:pPr algn="ctr"/>
            <a:r>
              <a:rPr lang="en-US" altLang="ko-KR" sz="1400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lx2</a:t>
            </a:r>
            <a:endParaRPr lang="ko-KR" altLang="en-US" sz="1400" b="1" dirty="0">
              <a:solidFill>
                <a:srgbClr val="FF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E2A5D312-27A9-222C-5B5F-235DE19AC19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47855" y="703600"/>
            <a:ext cx="888617" cy="5608800"/>
          </a:xfrm>
          <a:prstGeom prst="rect">
            <a:avLst/>
          </a:prstGeom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98507862-196A-D4A3-3814-6C481769DA7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72959" y="703600"/>
            <a:ext cx="888617" cy="5608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12144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그림 13">
            <a:extLst>
              <a:ext uri="{FF2B5EF4-FFF2-40B4-BE49-F238E27FC236}">
                <a16:creationId xmlns:a16="http://schemas.microsoft.com/office/drawing/2014/main" id="{8414195F-B9D3-8C2D-D758-69276399C71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79891" y="0"/>
            <a:ext cx="6832218" cy="6858000"/>
          </a:xfrm>
          <a:prstGeom prst="rect">
            <a:avLst/>
          </a:prstGeom>
        </p:spPr>
      </p:pic>
      <p:pic>
        <p:nvPicPr>
          <p:cNvPr id="16" name="그림 15">
            <a:extLst>
              <a:ext uri="{FF2B5EF4-FFF2-40B4-BE49-F238E27FC236}">
                <a16:creationId xmlns:a16="http://schemas.microsoft.com/office/drawing/2014/main" id="{1A0F3A02-7262-CC0C-D601-96B013ABD6A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79891" y="0"/>
            <a:ext cx="6832218" cy="6858000"/>
          </a:xfrm>
          <a:prstGeom prst="rect">
            <a:avLst/>
          </a:prstGeom>
        </p:spPr>
      </p:pic>
      <p:pic>
        <p:nvPicPr>
          <p:cNvPr id="18" name="그림 17">
            <a:extLst>
              <a:ext uri="{FF2B5EF4-FFF2-40B4-BE49-F238E27FC236}">
                <a16:creationId xmlns:a16="http://schemas.microsoft.com/office/drawing/2014/main" id="{3599350F-AEA9-DC6F-2DDE-83C9013141E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79891" y="0"/>
            <a:ext cx="6832218" cy="6858000"/>
          </a:xfrm>
          <a:prstGeom prst="rect">
            <a:avLst/>
          </a:prstGeom>
        </p:spPr>
      </p:pic>
      <p:sp>
        <p:nvSpPr>
          <p:cNvPr id="6" name="직사각형 5">
            <a:extLst>
              <a:ext uri="{FF2B5EF4-FFF2-40B4-BE49-F238E27FC236}">
                <a16:creationId xmlns:a16="http://schemas.microsoft.com/office/drawing/2014/main" id="{4481CD4D-FDA0-C124-1B47-5867A8954816}"/>
              </a:ext>
            </a:extLst>
          </p:cNvPr>
          <p:cNvSpPr/>
          <p:nvPr/>
        </p:nvSpPr>
        <p:spPr>
          <a:xfrm>
            <a:off x="2960223" y="230656"/>
            <a:ext cx="5040000" cy="5040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80568569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그림 13">
            <a:extLst>
              <a:ext uri="{FF2B5EF4-FFF2-40B4-BE49-F238E27FC236}">
                <a16:creationId xmlns:a16="http://schemas.microsoft.com/office/drawing/2014/main" id="{63F50FFC-4987-D665-7EF0-E7D2F02BF75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79891" y="0"/>
            <a:ext cx="6832218" cy="6858000"/>
          </a:xfrm>
          <a:prstGeom prst="rect">
            <a:avLst/>
          </a:prstGeom>
        </p:spPr>
      </p:pic>
      <p:pic>
        <p:nvPicPr>
          <p:cNvPr id="16" name="그림 15">
            <a:extLst>
              <a:ext uri="{FF2B5EF4-FFF2-40B4-BE49-F238E27FC236}">
                <a16:creationId xmlns:a16="http://schemas.microsoft.com/office/drawing/2014/main" id="{C0F96C0D-6D78-3686-08E3-A556D12A48C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79891" y="0"/>
            <a:ext cx="6832218" cy="6858000"/>
          </a:xfrm>
          <a:prstGeom prst="rect">
            <a:avLst/>
          </a:prstGeom>
        </p:spPr>
      </p:pic>
      <p:pic>
        <p:nvPicPr>
          <p:cNvPr id="18" name="그림 17">
            <a:extLst>
              <a:ext uri="{FF2B5EF4-FFF2-40B4-BE49-F238E27FC236}">
                <a16:creationId xmlns:a16="http://schemas.microsoft.com/office/drawing/2014/main" id="{B6F761EF-12E0-C3BA-4597-BF9D161AA76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79891" y="0"/>
            <a:ext cx="6832218" cy="6858000"/>
          </a:xfrm>
          <a:prstGeom prst="rect">
            <a:avLst/>
          </a:prstGeom>
        </p:spPr>
      </p:pic>
      <p:sp>
        <p:nvSpPr>
          <p:cNvPr id="6" name="직사각형 5">
            <a:extLst>
              <a:ext uri="{FF2B5EF4-FFF2-40B4-BE49-F238E27FC236}">
                <a16:creationId xmlns:a16="http://schemas.microsoft.com/office/drawing/2014/main" id="{4481CD4D-FDA0-C124-1B47-5867A8954816}"/>
              </a:ext>
            </a:extLst>
          </p:cNvPr>
          <p:cNvSpPr/>
          <p:nvPr/>
        </p:nvSpPr>
        <p:spPr>
          <a:xfrm>
            <a:off x="3576000" y="756600"/>
            <a:ext cx="5040000" cy="5040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95818171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>
            <a:extLst>
              <a:ext uri="{FF2B5EF4-FFF2-40B4-BE49-F238E27FC236}">
                <a16:creationId xmlns:a16="http://schemas.microsoft.com/office/drawing/2014/main" id="{31950840-EB13-205D-E75E-C363241C31A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79891" y="0"/>
            <a:ext cx="6832218" cy="6858000"/>
          </a:xfrm>
          <a:prstGeom prst="rect">
            <a:avLst/>
          </a:prstGeom>
        </p:spPr>
      </p:pic>
      <p:pic>
        <p:nvPicPr>
          <p:cNvPr id="8" name="그림 7">
            <a:extLst>
              <a:ext uri="{FF2B5EF4-FFF2-40B4-BE49-F238E27FC236}">
                <a16:creationId xmlns:a16="http://schemas.microsoft.com/office/drawing/2014/main" id="{4299BEB8-3A5D-FFE4-3EA6-AFCA715C47A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79891" y="0"/>
            <a:ext cx="6832218" cy="6858000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0A779B07-E3A2-1E94-35BD-22C8904D1DA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79891" y="0"/>
            <a:ext cx="6832218" cy="6858000"/>
          </a:xfrm>
          <a:prstGeom prst="rect">
            <a:avLst/>
          </a:prstGeom>
        </p:spPr>
      </p:pic>
      <p:sp>
        <p:nvSpPr>
          <p:cNvPr id="6" name="직사각형 5">
            <a:extLst>
              <a:ext uri="{FF2B5EF4-FFF2-40B4-BE49-F238E27FC236}">
                <a16:creationId xmlns:a16="http://schemas.microsoft.com/office/drawing/2014/main" id="{4481CD4D-FDA0-C124-1B47-5867A8954816}"/>
              </a:ext>
            </a:extLst>
          </p:cNvPr>
          <p:cNvSpPr/>
          <p:nvPr/>
        </p:nvSpPr>
        <p:spPr>
          <a:xfrm>
            <a:off x="3443726" y="680400"/>
            <a:ext cx="5040000" cy="5040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1931196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4</TotalTime>
  <Words>20</Words>
  <Application>Microsoft Office PowerPoint</Application>
  <PresentationFormat>와이드스크린</PresentationFormat>
  <Paragraphs>12</Paragraphs>
  <Slides>6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6</vt:i4>
      </vt:variant>
    </vt:vector>
  </HeadingPairs>
  <TitlesOfParts>
    <vt:vector size="9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 원영</dc:creator>
  <cp:lastModifiedBy>이 원영</cp:lastModifiedBy>
  <cp:revision>16</cp:revision>
  <dcterms:created xsi:type="dcterms:W3CDTF">2023-12-13T07:27:58Z</dcterms:created>
  <dcterms:modified xsi:type="dcterms:W3CDTF">2024-09-30T04:12:07Z</dcterms:modified>
</cp:coreProperties>
</file>